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76"/>
    <p:restoredTop sz="94683"/>
  </p:normalViewPr>
  <p:slideViewPr>
    <p:cSldViewPr snapToGrid="0" snapToObjects="1">
      <p:cViewPr varScale="1">
        <p:scale>
          <a:sx n="102" d="100"/>
          <a:sy n="102" d="100"/>
        </p:scale>
        <p:origin x="70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512C6-20EF-1D46-9CF9-80B1DA675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C782880-0AC0-BC41-824F-3C3EF1FD79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4859F-7CDF-2643-980F-77BBDFF23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53C66-32A5-294C-8080-9286248B2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F3818-662F-4441-B2EA-7969F00A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0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CFA63-39A6-7B4A-8AF3-57625E1ED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76DF31-988F-E447-954A-D10512BF3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527DE-E6F0-0E46-A532-A7BAB63C5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6F3A6-663A-7647-BA21-E84ACEFDA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31B35-F7DD-B14C-A46D-F0C5AF3CB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690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E93635-9DDB-784A-8FB2-6D4641933E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C8878D-1886-3A42-9EB0-FC4619B38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589729-6524-7941-B285-1BE43EA9E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9E42BD-9FB2-684D-BBBA-95C3845AD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580EE-F677-C743-9BA0-156EB783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82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E413E0-E1EE-0F49-88AF-56C3DA98E6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3D2141-AB5B-6848-8D4B-70A031CFB5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8AA4C-D9D9-B942-8AB7-16D3DADA5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C2E6E-F9A9-1145-AC60-237EC11BB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0393F-49FA-1746-9A68-E8F8051BB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15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270E7-916D-AD45-905B-1B8D487A0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BB7D3-194E-4847-9878-D3B33D406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75A4-0608-E245-8519-69333537A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9D5DC-1DE3-744F-9FC4-9A3B5629C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BD390-B1CE-BA4D-BB7B-D701550BE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345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07E3-3E6C-164B-B9CE-039D3FF67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B1C23D-9D20-9747-9223-452716592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D8284B-2D5A-8B4C-9906-A23D820B4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BC70CA-B061-284F-8267-2E9C25D5D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EAD765-2F80-A84A-B937-E46F12301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6CF04C-1572-3A46-8787-0D528E5F8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04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46C64-20FF-7842-B4E5-DA3131611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E4E339-B7BB-2242-BF8A-FF24E8C48E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426AB9-01CF-FB4B-BC22-75B1B625C0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A00B42-F7C0-6D43-9609-83E4C93DC9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5F0EFF-F4C3-3A44-84B0-0AEFB801B0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859AE6-7A96-2340-893E-508ADF52B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3F2D24-5851-F942-8E22-C503F16BB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F90E24D-EC6D-494C-B29F-870CD16E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295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0D2812-CF4C-A946-A6C5-FBF1ABA41D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25B51D-5E36-D841-8A18-27DBAF28D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34BC82-93BF-AC4C-BE58-25E5D77AF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B6414C-8829-C04D-9345-BD5086FCD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431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030F62-BD9F-5942-A15C-A10CDD20C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B52502-235D-FD48-AFD8-8B89BB9A6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9936A4-585C-3440-B6E4-3A40A2216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402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C95306-30B0-034B-88AD-18BB0F59E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C548DA-E7CB-3048-9D8F-883F0B1290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65F38E-39BF-174F-83F8-E69957D5F3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7D2A6A-B251-B44D-93CD-F91AB9B7A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048151-1916-314C-B3A6-EE4F666EF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6F6580-37A3-F54C-AC51-B8C1E5B21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451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B97A22-D255-E840-A85D-4E9541679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384AAE-E261-DE4D-A959-F57216CC1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B11EEE-2497-FD44-A629-0DCEC8E13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5BC24-B954-A042-BA48-1BAB40666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688EE6-D0CE-1A48-BEAC-A930D3149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C94DB1-4E2F-2F44-857B-0723BB704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60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F5699F-66D9-C24A-BF03-79A0D706D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F659FE-067B-DC46-86FF-0A62C5AEC4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AD5BE-5DFB-864E-A0F8-AC28A6A1D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A1C04-222A-5746-B6EE-CB9A53927F07}" type="datetimeFigureOut">
              <a:rPr lang="en-US" smtClean="0"/>
              <a:t>6/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4DC74-F985-B04D-A9DB-9EB011C5CE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3A99FC-4C6A-764C-9DCA-D4491B017F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C4111-BDF8-C945-B5E2-EA1B89062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>
            <a:extLst>
              <a:ext uri="{FF2B5EF4-FFF2-40B4-BE49-F238E27FC236}">
                <a16:creationId xmlns:a16="http://schemas.microsoft.com/office/drawing/2014/main" id="{3F4F2358-A6E6-D443-9037-201293B0DB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758" y="457462"/>
            <a:ext cx="2450010" cy="23762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8B9DFBC-F427-CF40-88F8-0827E841E41C}"/>
              </a:ext>
            </a:extLst>
          </p:cNvPr>
          <p:cNvSpPr txBox="1"/>
          <p:nvPr/>
        </p:nvSpPr>
        <p:spPr>
          <a:xfrm>
            <a:off x="2639616" y="1078151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340A3BE-785C-6943-8136-52AEAC2EFFFC}"/>
              </a:ext>
            </a:extLst>
          </p:cNvPr>
          <p:cNvGrpSpPr/>
          <p:nvPr/>
        </p:nvGrpSpPr>
        <p:grpSpPr>
          <a:xfrm>
            <a:off x="4164696" y="574094"/>
            <a:ext cx="2507368" cy="2376264"/>
            <a:chOff x="3131840" y="404664"/>
            <a:chExt cx="2507368" cy="2376264"/>
          </a:xfrm>
        </p:grpSpPr>
        <p:pic>
          <p:nvPicPr>
            <p:cNvPr id="7" name="Picture 3">
              <a:extLst>
                <a:ext uri="{FF2B5EF4-FFF2-40B4-BE49-F238E27FC236}">
                  <a16:creationId xmlns:a16="http://schemas.microsoft.com/office/drawing/2014/main" id="{87A7A9FF-6891-7B4A-891B-561C29DDA1A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1840" y="404664"/>
              <a:ext cx="2507368" cy="23762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5476EEF-6F1A-4D4E-A487-D20F0B2902B6}"/>
                </a:ext>
              </a:extLst>
            </p:cNvPr>
            <p:cNvSpPr txBox="1"/>
            <p:nvPr/>
          </p:nvSpPr>
          <p:spPr>
            <a:xfrm>
              <a:off x="3707904" y="620688"/>
              <a:ext cx="7409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 cells</a:t>
              </a:r>
            </a:p>
          </p:txBody>
        </p:sp>
      </p:grp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37E159D9-CA50-E84E-8C67-A13D48FF6EC2}"/>
              </a:ext>
            </a:extLst>
          </p:cNvPr>
          <p:cNvCxnSpPr>
            <a:cxnSpLocks/>
          </p:cNvCxnSpPr>
          <p:nvPr/>
        </p:nvCxnSpPr>
        <p:spPr>
          <a:xfrm>
            <a:off x="2207568" y="1438190"/>
            <a:ext cx="1944216" cy="7200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FEB7328-159F-8F4F-A382-C98087AF8FBE}"/>
              </a:ext>
            </a:extLst>
          </p:cNvPr>
          <p:cNvCxnSpPr>
            <a:cxnSpLocks/>
          </p:cNvCxnSpPr>
          <p:nvPr/>
        </p:nvCxnSpPr>
        <p:spPr>
          <a:xfrm flipH="1">
            <a:off x="3791744" y="1438190"/>
            <a:ext cx="1368152" cy="237626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7" name="Group 36">
            <a:extLst>
              <a:ext uri="{FF2B5EF4-FFF2-40B4-BE49-F238E27FC236}">
                <a16:creationId xmlns:a16="http://schemas.microsoft.com/office/drawing/2014/main" id="{302C3256-5FC9-A64D-B546-8FAE4EAC1322}"/>
              </a:ext>
            </a:extLst>
          </p:cNvPr>
          <p:cNvGrpSpPr/>
          <p:nvPr/>
        </p:nvGrpSpPr>
        <p:grpSpPr>
          <a:xfrm>
            <a:off x="6822436" y="275805"/>
            <a:ext cx="3384376" cy="3218476"/>
            <a:chOff x="323528" y="3290348"/>
            <a:chExt cx="3635896" cy="3457666"/>
          </a:xfrm>
        </p:grpSpPr>
        <p:pic>
          <p:nvPicPr>
            <p:cNvPr id="15" name="Picture 4">
              <a:extLst>
                <a:ext uri="{FF2B5EF4-FFF2-40B4-BE49-F238E27FC236}">
                  <a16:creationId xmlns:a16="http://schemas.microsoft.com/office/drawing/2014/main" id="{863FFA90-6447-974B-9B0B-2EB14BC3BDC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528" y="3290348"/>
              <a:ext cx="3635896" cy="3457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75C06D3-B2BF-D742-BAB9-A10E9308AE3B}"/>
                </a:ext>
              </a:extLst>
            </p:cNvPr>
            <p:cNvSpPr txBox="1"/>
            <p:nvPr/>
          </p:nvSpPr>
          <p:spPr>
            <a:xfrm>
              <a:off x="842942" y="5332936"/>
              <a:ext cx="1488270" cy="3306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+ eff/mem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42DE5A0-9FFD-AB48-9CA0-28D6CEF16AF9}"/>
                </a:ext>
              </a:extLst>
            </p:cNvPr>
            <p:cNvSpPr txBox="1"/>
            <p:nvPr/>
          </p:nvSpPr>
          <p:spPr>
            <a:xfrm>
              <a:off x="2570574" y="3400335"/>
              <a:ext cx="1262670" cy="3306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+ Naiv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19659D4-E37C-0747-A414-0C3DEC44CC32}"/>
                </a:ext>
              </a:extLst>
            </p:cNvPr>
            <p:cNvSpPr txBox="1"/>
            <p:nvPr/>
          </p:nvSpPr>
          <p:spPr>
            <a:xfrm>
              <a:off x="899592" y="3400335"/>
              <a:ext cx="1434883" cy="3306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+ TEMR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0703012-5B4D-F744-8645-B1BE55D127B4}"/>
                </a:ext>
              </a:extLst>
            </p:cNvPr>
            <p:cNvSpPr txBox="1"/>
            <p:nvPr/>
          </p:nvSpPr>
          <p:spPr>
            <a:xfrm>
              <a:off x="2388195" y="5332936"/>
              <a:ext cx="1465882" cy="5621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+ Central </a:t>
              </a:r>
            </a:p>
            <a:p>
              <a:pPr algn="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emory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A59BBA87-DC41-E84F-B780-45FC8368B2DC}"/>
              </a:ext>
            </a:extLst>
          </p:cNvPr>
          <p:cNvGrpSpPr/>
          <p:nvPr/>
        </p:nvGrpSpPr>
        <p:grpSpPr>
          <a:xfrm>
            <a:off x="6816080" y="3598430"/>
            <a:ext cx="3456384" cy="3286954"/>
            <a:chOff x="5220072" y="4581128"/>
            <a:chExt cx="3635896" cy="3457666"/>
          </a:xfrm>
        </p:grpSpPr>
        <p:pic>
          <p:nvPicPr>
            <p:cNvPr id="21" name="Picture 6">
              <a:extLst>
                <a:ext uri="{FF2B5EF4-FFF2-40B4-BE49-F238E27FC236}">
                  <a16:creationId xmlns:a16="http://schemas.microsoft.com/office/drawing/2014/main" id="{68E2616D-409D-5649-A16A-C0496B81ABC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0072" y="4581128"/>
              <a:ext cx="3635896" cy="3457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469C026C-4408-9847-9FA9-5B84BB17B86E}"/>
                </a:ext>
              </a:extLst>
            </p:cNvPr>
            <p:cNvGrpSpPr/>
            <p:nvPr/>
          </p:nvGrpSpPr>
          <p:grpSpPr>
            <a:xfrm>
              <a:off x="5792987" y="4663372"/>
              <a:ext cx="2987233" cy="2227649"/>
              <a:chOff x="5792987" y="4663372"/>
              <a:chExt cx="2987233" cy="2227649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473FCA6-8D92-6647-A019-A33992A9B88B}"/>
                  </a:ext>
                </a:extLst>
              </p:cNvPr>
              <p:cNvSpPr txBox="1"/>
              <p:nvPr/>
            </p:nvSpPr>
            <p:spPr>
              <a:xfrm>
                <a:off x="5792987" y="6391106"/>
                <a:ext cx="1457264" cy="3237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+ eff/mem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48F32151-AD3F-B144-879E-4427DB992C03}"/>
                  </a:ext>
                </a:extLst>
              </p:cNvPr>
              <p:cNvSpPr txBox="1"/>
              <p:nvPr/>
            </p:nvSpPr>
            <p:spPr>
              <a:xfrm>
                <a:off x="7543856" y="4663372"/>
                <a:ext cx="1236364" cy="3237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+ Naive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E3F2A61-09CA-A448-8BF8-40AB626A3881}"/>
                  </a:ext>
                </a:extLst>
              </p:cNvPr>
              <p:cNvSpPr txBox="1"/>
              <p:nvPr/>
            </p:nvSpPr>
            <p:spPr>
              <a:xfrm>
                <a:off x="5796136" y="4725144"/>
                <a:ext cx="1404990" cy="3237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+ TEMRA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E0740839-BAD3-E94F-8D4B-64B7CF1C9806}"/>
                  </a:ext>
                </a:extLst>
              </p:cNvPr>
              <p:cNvSpPr txBox="1"/>
              <p:nvPr/>
            </p:nvSpPr>
            <p:spPr>
              <a:xfrm>
                <a:off x="7245071" y="6340627"/>
                <a:ext cx="1435343" cy="55039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+ Central </a:t>
                </a:r>
              </a:p>
              <a:p>
                <a:pPr algn="r"/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mory</a:t>
                </a:r>
              </a:p>
            </p:txBody>
          </p:sp>
        </p:grp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AAC5E069-6FDD-0446-A260-21DE18D2FEB4}"/>
              </a:ext>
            </a:extLst>
          </p:cNvPr>
          <p:cNvGrpSpPr/>
          <p:nvPr/>
        </p:nvGrpSpPr>
        <p:grpSpPr>
          <a:xfrm>
            <a:off x="2279576" y="3886463"/>
            <a:ext cx="2914650" cy="2771775"/>
            <a:chOff x="5436096" y="-18139"/>
            <a:chExt cx="2914650" cy="2771775"/>
          </a:xfrm>
        </p:grpSpPr>
        <p:pic>
          <p:nvPicPr>
            <p:cNvPr id="9" name="Picture 4">
              <a:extLst>
                <a:ext uri="{FF2B5EF4-FFF2-40B4-BE49-F238E27FC236}">
                  <a16:creationId xmlns:a16="http://schemas.microsoft.com/office/drawing/2014/main" id="{CF04E661-6334-7149-8E18-3BE149D7549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-18139"/>
              <a:ext cx="2914650" cy="277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BF506AA-FB4F-E240-A340-9FB02CA79A14}"/>
                </a:ext>
              </a:extLst>
            </p:cNvPr>
            <p:cNvSpPr txBox="1"/>
            <p:nvPr/>
          </p:nvSpPr>
          <p:spPr>
            <a:xfrm>
              <a:off x="5940152" y="53869"/>
              <a:ext cx="12538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4+ T cell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702571-1D43-A141-ADBD-635B70B18692}"/>
                </a:ext>
              </a:extLst>
            </p:cNvPr>
            <p:cNvSpPr txBox="1"/>
            <p:nvPr/>
          </p:nvSpPr>
          <p:spPr>
            <a:xfrm>
              <a:off x="7092280" y="2053885"/>
              <a:ext cx="12538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D8+ T cells</a:t>
              </a:r>
            </a:p>
          </p:txBody>
        </p:sp>
      </p:grp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DDD6EE51-98A8-DA42-B65E-04AA8CA3F8B8}"/>
              </a:ext>
            </a:extLst>
          </p:cNvPr>
          <p:cNvCxnSpPr>
            <a:cxnSpLocks/>
          </p:cNvCxnSpPr>
          <p:nvPr/>
        </p:nvCxnSpPr>
        <p:spPr>
          <a:xfrm flipV="1">
            <a:off x="3486215" y="2862214"/>
            <a:ext cx="3640973" cy="162880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4CCBD95E-95A4-224E-82DC-3A41CF645107}"/>
              </a:ext>
            </a:extLst>
          </p:cNvPr>
          <p:cNvCxnSpPr>
            <a:cxnSpLocks/>
          </p:cNvCxnSpPr>
          <p:nvPr/>
        </p:nvCxnSpPr>
        <p:spPr>
          <a:xfrm>
            <a:off x="4655841" y="5686662"/>
            <a:ext cx="2571714" cy="10761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CA63283-1BB8-5042-80FD-5E0B98D02245}"/>
              </a:ext>
            </a:extLst>
          </p:cNvPr>
          <p:cNvSpPr txBox="1"/>
          <p:nvPr/>
        </p:nvSpPr>
        <p:spPr>
          <a:xfrm>
            <a:off x="385762" y="56101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622359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5</TotalTime>
  <Words>44</Words>
  <Application>Microsoft Macintosh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ev Gupta</dc:creator>
  <cp:lastModifiedBy>Rajeev Gupta</cp:lastModifiedBy>
  <cp:revision>23</cp:revision>
  <dcterms:created xsi:type="dcterms:W3CDTF">2021-05-16T12:17:13Z</dcterms:created>
  <dcterms:modified xsi:type="dcterms:W3CDTF">2021-06-03T09:08:25Z</dcterms:modified>
</cp:coreProperties>
</file>